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300788" cy="54006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C9FBD-D3DB-4303-8AA3-717F03A434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543384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33440" y="3227760"/>
            <a:ext cx="543384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D6865-F25D-4D6D-90C8-6F67A23C99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17680" y="143820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33440" y="322776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17680" y="322776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856B8-9F14-43C4-9EEA-0BD5DB57D0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17496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70880" y="1438200"/>
            <a:ext cx="17496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08320" y="1438200"/>
            <a:ext cx="17496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33440" y="3227760"/>
            <a:ext cx="17496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70880" y="3227760"/>
            <a:ext cx="17496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08320" y="3227760"/>
            <a:ext cx="17496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79026-090E-48E5-9ECB-A7DA81AA44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33440" y="1438200"/>
            <a:ext cx="5433840" cy="342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689"/>
              </a:spcBef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0AA46-37D4-446E-B97A-83008ADFAC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5433840" cy="342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13BC4-BA25-492D-A33D-CC29D1A0EE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2651400" cy="342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17680" y="1438200"/>
            <a:ext cx="2651400" cy="342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B7988-A620-464F-B98B-DDE9B7D26D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1503B-D3F7-46B0-90B3-7CE3488D1F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33440" y="287280"/>
            <a:ext cx="5433840" cy="484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689"/>
              </a:spcBef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82D63-944A-4EFE-A204-4CE1D33555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17680" y="1438200"/>
            <a:ext cx="2651400" cy="342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33440" y="322776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80F78-0389-4CC2-AE17-FB41EDE481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2651400" cy="342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17680" y="143820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17680" y="322776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25C88-7A98-40AD-9890-99162F0BEA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33440" y="143820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17680" y="1438200"/>
            <a:ext cx="265140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33440" y="3227760"/>
            <a:ext cx="5433840" cy="1634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3BF31-4FBE-4B04-92E0-777D81ADBA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33440" y="287280"/>
            <a:ext cx="5433840" cy="10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33440" y="1438200"/>
            <a:ext cx="5433840" cy="342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57320" indent="-1573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1" marL="471600" indent="-1573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2" marL="787320" indent="-15696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3" marL="1101600" indent="-15696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4" marL="1417680" indent="-1573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5" marL="1417680" indent="-1573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6" marL="1417680" indent="-1573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8560"/>
                <a:tab algn="l" pos="1257480"/>
                <a:tab algn="l" pos="1886040"/>
                <a:tab algn="l" pos="2514600"/>
                <a:tab algn="l" pos="3143160"/>
                <a:tab algn="l" pos="3772080"/>
                <a:tab algn="l" pos="4400640"/>
                <a:tab algn="l" pos="5029200"/>
                <a:tab algn="l" pos="5657760"/>
                <a:tab algn="l" pos="6286680"/>
                <a:tab algn="l" pos="6915240"/>
                <a:tab algn="l" pos="7543800"/>
                <a:tab algn="l" pos="8172360"/>
                <a:tab algn="l" pos="8801280"/>
                <a:tab algn="l" pos="9429840"/>
                <a:tab algn="l" pos="10058400"/>
                <a:tab algn="l" pos="10686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3440" y="5005440"/>
            <a:ext cx="1417680" cy="28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8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8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87640" y="5005440"/>
            <a:ext cx="2125440" cy="28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49600" y="5005440"/>
            <a:ext cx="1417680" cy="28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8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F24B087-747B-4E12-8996-6EA66AEB6976}" type="slidenum">
              <a:rPr b="0" lang="zh-CN" sz="8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2" descr=""/>
          <p:cNvPicPr/>
          <p:nvPr/>
        </p:nvPicPr>
        <p:blipFill>
          <a:blip r:embed="rId1"/>
          <a:stretch/>
        </p:blipFill>
        <p:spPr>
          <a:xfrm>
            <a:off x="244440" y="144360"/>
            <a:ext cx="6045120" cy="502920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1"/>
          <p:cNvSpPr/>
          <p:nvPr/>
        </p:nvSpPr>
        <p:spPr>
          <a:xfrm>
            <a:off x="3038400" y="508464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  <a:ea typeface="等线"/>
              </a:rPr>
              <a:t>Cancer sta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2"/>
          <p:cNvSpPr/>
          <p:nvPr/>
        </p:nvSpPr>
        <p:spPr>
          <a:xfrm rot="16200000">
            <a:off x="-761400" y="2467800"/>
            <a:ext cx="17517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等线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 (gene expression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图片 2" descr=""/>
          <p:cNvPicPr/>
          <p:nvPr/>
        </p:nvPicPr>
        <p:blipFill>
          <a:blip r:embed="rId1"/>
          <a:stretch/>
        </p:blipFill>
        <p:spPr>
          <a:xfrm>
            <a:off x="252360" y="152280"/>
            <a:ext cx="6045120" cy="5029200"/>
          </a:xfrm>
          <a:prstGeom prst="rect">
            <a:avLst/>
          </a:prstGeom>
          <a:ln w="0">
            <a:noFill/>
          </a:ln>
        </p:spPr>
      </p:pic>
      <p:sp>
        <p:nvSpPr>
          <p:cNvPr id="45" name="文本框 1"/>
          <p:cNvSpPr/>
          <p:nvPr/>
        </p:nvSpPr>
        <p:spPr>
          <a:xfrm>
            <a:off x="3038400" y="508464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  <a:ea typeface="等线"/>
              </a:rPr>
              <a:t>Cancer sta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2"/>
          <p:cNvSpPr/>
          <p:nvPr/>
        </p:nvSpPr>
        <p:spPr>
          <a:xfrm rot="16200000">
            <a:off x="-761400" y="2467800"/>
            <a:ext cx="17517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等线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 (gene expression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片 2" descr=""/>
          <p:cNvPicPr/>
          <p:nvPr/>
        </p:nvPicPr>
        <p:blipFill>
          <a:blip r:embed="rId1"/>
          <a:stretch/>
        </p:blipFill>
        <p:spPr>
          <a:xfrm>
            <a:off x="244440" y="77760"/>
            <a:ext cx="6045120" cy="5029200"/>
          </a:xfrm>
          <a:prstGeom prst="rect">
            <a:avLst/>
          </a:prstGeom>
          <a:ln w="0">
            <a:noFill/>
          </a:ln>
        </p:spPr>
      </p:pic>
      <p:sp>
        <p:nvSpPr>
          <p:cNvPr id="48" name="文本框 3"/>
          <p:cNvSpPr/>
          <p:nvPr/>
        </p:nvSpPr>
        <p:spPr>
          <a:xfrm>
            <a:off x="344520" y="-8820000"/>
            <a:ext cx="56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20800"/>
                <a:tab algn="l" pos="1641600"/>
                <a:tab algn="l" pos="2462040"/>
                <a:tab algn="l" pos="3282840"/>
                <a:tab algn="l" pos="4103640"/>
                <a:tab algn="l" pos="4924440"/>
                <a:tab algn="l" pos="5745240"/>
                <a:tab algn="l" pos="6566040"/>
                <a:tab algn="l" pos="7386480"/>
                <a:tab algn="l" pos="8207280"/>
                <a:tab algn="l" pos="9028080"/>
                <a:tab algn="l" pos="9848880"/>
                <a:tab algn="l" pos="106696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1"/>
          <p:cNvSpPr/>
          <p:nvPr/>
        </p:nvSpPr>
        <p:spPr>
          <a:xfrm>
            <a:off x="3198240" y="5321160"/>
            <a:ext cx="60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Grou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1"/>
          <p:cNvSpPr/>
          <p:nvPr/>
        </p:nvSpPr>
        <p:spPr>
          <a:xfrm>
            <a:off x="2828880" y="307980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  <a:ea typeface="等线"/>
              </a:rPr>
              <a:t>Cancer sta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2"/>
          <p:cNvSpPr/>
          <p:nvPr/>
        </p:nvSpPr>
        <p:spPr>
          <a:xfrm rot="16200000">
            <a:off x="-761400" y="1411920"/>
            <a:ext cx="17517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等线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等线"/>
              </a:rPr>
              <a:t> (gene expression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7-17T13:15:19Z</dcterms:created>
  <dc:creator/>
  <dc:description/>
  <dc:language>en-US</dc:language>
  <cp:lastModifiedBy/>
  <dcterms:modified xsi:type="dcterms:W3CDTF">2019-04-18T03:46:18Z</dcterms:modified>
  <cp:revision>0</cp:revision>
  <dc:subject/>
  <dc:title/>
</cp:coreProperties>
</file>